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B78C37D-F01A-48EE-9415-BF53D1FA7B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C1F48B1-C973-4AE9-A744-F98505B8D8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C1E19B7-C04B-4AAB-9EB0-A274EDFB4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C16C7A4-4884-46E1-827E-8535FD305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0263ED9-F10C-4701-90C4-CA46525D9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575644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07C80C-AC04-4B85-87A8-03F9362F26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708A653-8BC3-4C59-B160-79CD5E8976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5149B9F-369D-4452-BDF5-72A5A11E1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9E068FA-B32E-4308-9790-00F9ACABD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9007CA5-37E6-4094-BBB6-8412E5DC9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32682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00C720D-CCF4-4E84-94E2-3ADBF935B6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F4E8EEB-0E1D-4CE5-8DF4-A3A2A16FA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684BF6A-2E66-4735-9BB3-2DEFBFF86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5C1388-42AF-449A-9FA5-1876D40B2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492FAB9-EDFF-4EB6-89D5-A60CF13B7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57578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7E82A9A-861D-41C4-AA24-E27BEA790B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6C9532A-14D6-427B-A422-A47FF614A7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FD66D84-37AF-4380-8CBF-396F149D5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1E419B6-C332-4E98-94A6-C73555AB3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D9DFDA8-2CBB-444D-93C8-9BF978CD1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44695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97D037-C058-41A2-BE9A-18EEDAD55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AF41DB1-7579-4657-A080-485390DDE9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6E803F2-AEF9-4DB8-A9F8-DDE13DD68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F993837-E812-4487-8AC3-E36C8BAEE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EA31F5E-3338-465A-8178-1919A976A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08759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408A868-C3DB-4458-A2FA-BF92FC46E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1DBA90D-B6BC-4DA2-A50E-5B9232CEA9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19D6946-BEE0-4610-BD43-9DD0DBCBCA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CE12F37-AEB9-485B-8D12-8F2D9431B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035D511-339E-4C05-A905-2251EC5295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B2BE62B-D6BA-4795-927F-457B71CD0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985520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B23AF02-0AD4-4397-99B8-6016A3059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E59E250-7E12-49CE-9E00-86D9A3ACC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53A36AF-5D35-4CF7-A7FA-FBC4278412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2A5E65A-7331-484D-8EAA-B7ADEE069D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34B4FB2-62CF-46AB-8308-9F099143C3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63E39C4-80B1-4FCC-A2F2-84304E7F2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E9FE66A-1A9E-4C63-8F34-101DF11F3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93EE281-8126-446F-BCF0-5A6415C82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660021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5F1725-8246-4965-BC0C-B858419D7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4D8B060-114A-4614-B73B-9F8DF673F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AC0A6D1-0BE9-4816-9AA2-EC7399CFA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7586C3DB-810A-4AC1-AD33-2E422564D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025033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6ECF1041-D862-4379-8B15-3EB70AA9A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0C1D7056-1B7D-421E-B5C7-E0F720782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EBA0DEE-C6C4-47D4-B7A4-C601AFBA5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41752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DD5654-7C9D-4830-B7F2-34079480CC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F724288-D011-42E6-AB93-444BB319C5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CDF5FC7-E374-4187-BCA4-9D607862F7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1D5071C-384A-4237-8738-C9F45BFD6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1EFEA7B-154E-4637-87FA-C165BB961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DE79313-0DCD-4959-822B-AB2608E9C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5744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6E4E4A-B850-48C8-973E-5718A125DF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A937653-3D17-4316-8941-B816032268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1A023FA-C8AE-4A63-8A97-D5EB6AFF4D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3BB9563-4B9B-4CEB-A3AB-4FC01ECB2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7D46FB1-E611-425F-B271-E1204D192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5E766A4-2664-4F5F-9B83-0056E6C72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23296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E6B423A-8F69-41B7-A64D-73A823CBA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5ED15B9-9C6D-45A3-9FA5-108FCCB843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B199B47-D44C-4780-BB98-C4E32B4EAD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E43EA3A-A670-40AB-8EBA-684B8CD027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3FDED2D-4089-4762-95CF-277D6497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08594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magen 29">
            <a:extLst>
              <a:ext uri="{FF2B5EF4-FFF2-40B4-BE49-F238E27FC236}">
                <a16:creationId xmlns:a16="http://schemas.microsoft.com/office/drawing/2014/main" id="{B9026ED3-6FC1-4D2E-952F-DD8498D0EB5A}"/>
              </a:ext>
            </a:extLst>
          </p:cNvPr>
          <p:cNvPicPr/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0758" y="73625"/>
            <a:ext cx="9170483" cy="5571067"/>
          </a:xfrm>
          <a:prstGeom prst="rect">
            <a:avLst/>
          </a:prstGeom>
          <a:noFill/>
        </p:spPr>
      </p:pic>
      <p:sp>
        <p:nvSpPr>
          <p:cNvPr id="4" name="Rectángulo 3">
            <a:extLst>
              <a:ext uri="{FF2B5EF4-FFF2-40B4-BE49-F238E27FC236}">
                <a16:creationId xmlns:a16="http://schemas.microsoft.com/office/drawing/2014/main" id="{4325A025-2272-4870-B0E1-114BE48B22CC}"/>
              </a:ext>
            </a:extLst>
          </p:cNvPr>
          <p:cNvSpPr/>
          <p:nvPr/>
        </p:nvSpPr>
        <p:spPr>
          <a:xfrm>
            <a:off x="1298711" y="5803715"/>
            <a:ext cx="902473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4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igure S2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. Polymerase chain reaction (PCR) analysis showing the presence of the fragment of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pg1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gene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specific of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Fusarium </a:t>
            </a:r>
            <a:r>
              <a:rPr lang="en-US" sz="1400" i="1" dirty="0" err="1">
                <a:latin typeface="Palatino Linotype" panose="02040502050505030304" pitchFamily="18" charset="0"/>
                <a:ea typeface="Times New Roman" panose="02020603050405020304" pitchFamily="18" charset="0"/>
              </a:rPr>
              <a:t>oxysporum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(Table 1), on 105 out </a:t>
            </a:r>
            <a:r>
              <a:rPr lang="en-US" sz="1400">
                <a:latin typeface="Palatino Linotype" panose="02040502050505030304" pitchFamily="18" charset="0"/>
                <a:ea typeface="Times New Roman" panose="02020603050405020304" pitchFamily="18" charset="0"/>
              </a:rPr>
              <a:t>of 119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ungal isolates, collected in this study (Table 2). Control DNA: R1=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ol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004,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. spp.=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uncharacterized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Fusarium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isolate. PCR product visualization was carried out following electrophoresis in a 1% agarose gel.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endParaRPr lang="es-CO" sz="14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17234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3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uricio Soto Suárez</dc:creator>
  <cp:lastModifiedBy>Mauricio Soto Suárez</cp:lastModifiedBy>
  <cp:revision>9</cp:revision>
  <dcterms:created xsi:type="dcterms:W3CDTF">2019-03-04T19:13:07Z</dcterms:created>
  <dcterms:modified xsi:type="dcterms:W3CDTF">2020-01-17T00:25:28Z</dcterms:modified>
</cp:coreProperties>
</file>